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85" d="100"/>
          <a:sy n="85" d="100"/>
        </p:scale>
        <p:origin x="59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5C67B6B-DC10-4B36-912D-652428B65AD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EEBC6B9-8343-4796-9F6C-BC8836F05F8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0201791-C004-48B5-BFA0-7F4C14F272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A2D133-173B-421F-B871-194608B494AB}" type="datetimeFigureOut">
              <a:rPr lang="en-US" smtClean="0"/>
              <a:t>12/16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79F5141-3423-4266-A04C-BDF00BFDAD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8ED4051-E877-4488-A0EC-B59417B728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ADBADE-6C06-45C2-9438-89C309DA2F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20751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12FC9E-A660-4AE4-943C-908E9CAE8B5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7E32C0D-E2CA-442B-960D-C2EB0F879A4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33A33DA-6A57-4A76-A135-4CED06EC8A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A2D133-173B-421F-B871-194608B494AB}" type="datetimeFigureOut">
              <a:rPr lang="en-US" smtClean="0"/>
              <a:t>12/16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CFD11CE-9310-4265-9BA9-FDD57C44AB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17E9DC4-1095-4B60-95C6-ABC6990EF0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ADBADE-6C06-45C2-9438-89C309DA2F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81385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45FDD32-6A8B-4CAD-98A3-95FA063DF0B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1173369-5C1D-461F-A770-3CE83616937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A37C55C-AFB1-4812-A98D-32A4632E57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A2D133-173B-421F-B871-194608B494AB}" type="datetimeFigureOut">
              <a:rPr lang="en-US" smtClean="0"/>
              <a:t>12/16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AF2831E-5300-4961-BD75-69947E01C4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44D970A-246D-4DF4-9187-0FD138B61F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ADBADE-6C06-45C2-9438-89C309DA2F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77576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851677-32FD-4C1F-AFF5-E83D0A44345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EEA6AC3-EF80-4721-9FD3-9C06E472113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422A99C-C8E2-4853-A020-8A0E93B8B3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A2D133-173B-421F-B871-194608B494AB}" type="datetimeFigureOut">
              <a:rPr lang="en-US" smtClean="0"/>
              <a:t>12/16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D76F566-CB3F-44BF-BF9E-915879D9B2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EEB7095-8B83-4254-95DC-9EE0661697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ADBADE-6C06-45C2-9438-89C309DA2F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84973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D0876D-5A8C-40FA-BF48-3A98C2864CC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E9A83A4-5405-47BC-9807-CF70B2932E7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2862495-20A7-48B7-8AC0-2B432B671B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A2D133-173B-421F-B871-194608B494AB}" type="datetimeFigureOut">
              <a:rPr lang="en-US" smtClean="0"/>
              <a:t>12/16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3FEACF5-C008-4638-A4E1-76236AF436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11DD5B5-6ED8-4BC7-8BEC-FED8EF5DAF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ADBADE-6C06-45C2-9438-89C309DA2F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96648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3B36DC-275F-4A2F-AFF1-DD6C04AD515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2D9521B-46BC-47C7-91B7-BC032E3DE47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1C967AF-981B-444D-B5FF-7B0EB32E73D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3C8C883-643B-4A6D-AB6A-8ACE59AE37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A2D133-173B-421F-B871-194608B494AB}" type="datetimeFigureOut">
              <a:rPr lang="en-US" smtClean="0"/>
              <a:t>12/16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43E6443-7599-4FF4-9826-C513C8F1F4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3E7CB9D-7D32-4EE4-B7D4-C4FBC2C93F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ADBADE-6C06-45C2-9438-89C309DA2F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28916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EF5B88-1C3D-4BF3-86DA-3447CB8FF5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81C957F-B94D-48C4-B4EE-AA7B3204B9E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F5FCAE5-878B-4514-AB21-9E3BA2650C6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58D4A59-55BE-4055-86C5-10EF15CBE8A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9FCFF30-0241-427B-B7AC-1BD94BE92CB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0B63BEF-A807-4AD2-B5BA-74AB17480D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A2D133-173B-421F-B871-194608B494AB}" type="datetimeFigureOut">
              <a:rPr lang="en-US" smtClean="0"/>
              <a:t>12/16/2019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834F995-B712-4351-95EB-AEEB06A674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145F6D5-602D-4745-9D68-359C258674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ADBADE-6C06-45C2-9438-89C309DA2F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48062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D233B85-BC4E-4507-8AED-874B9473841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3F8D13A-CF38-424C-AECB-EA5B2C5EC7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A2D133-173B-421F-B871-194608B494AB}" type="datetimeFigureOut">
              <a:rPr lang="en-US" smtClean="0"/>
              <a:t>12/16/2019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AA35EAB-8099-428C-B8D0-7C5DAB7F09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738E733-5F81-4437-92AA-F2D1DF4703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ADBADE-6C06-45C2-9438-89C309DA2F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19917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C025A30-1D0C-43E8-83B5-826B86A894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A2D133-173B-421F-B871-194608B494AB}" type="datetimeFigureOut">
              <a:rPr lang="en-US" smtClean="0"/>
              <a:t>12/16/2019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C2886C1-3E3F-4EE7-8AD0-496ED6A1F3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2620312-71CC-4C9C-8BBD-B2BBAAF717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ADBADE-6C06-45C2-9438-89C309DA2F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38169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5A5DFE-D5D4-4936-A5D9-58EEBC3EBC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1E57A39-08A7-4B42-8575-960C6B634BF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2090098-974A-4DDF-9781-CDBC0626379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9EE4230-B282-4F07-B082-C7D62EED90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A2D133-173B-421F-B871-194608B494AB}" type="datetimeFigureOut">
              <a:rPr lang="en-US" smtClean="0"/>
              <a:t>12/16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8773120-49B5-49FD-83A1-5559D80BAB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8BC4090-1D56-4278-AFF4-173FA3627C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ADBADE-6C06-45C2-9438-89C309DA2F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65256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9AE6EC1-7DC4-482C-9387-F64EBD4079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2BD4493-B91B-4A13-802D-A91FFC45114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547B20D-BC51-46A8-83AB-4B7585F94D2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66A0F2A-5C0F-47C9-81DA-E197B65F5B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A2D133-173B-421F-B871-194608B494AB}" type="datetimeFigureOut">
              <a:rPr lang="en-US" smtClean="0"/>
              <a:t>12/16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31C42B5-9477-41A6-B3B1-89AD9E976C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E7323BA-27A5-41D7-B90F-05B730FA21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ADBADE-6C06-45C2-9438-89C309DA2F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23758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579FD58-9F0A-4EC9-A0C2-42D220BB13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565FF8C-417D-4EC4-A10D-AC6109A4A89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F781558-25FF-457F-A72C-C674BE3767F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A2D133-173B-421F-B871-194608B494AB}" type="datetimeFigureOut">
              <a:rPr lang="en-US" smtClean="0"/>
              <a:t>12/16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3707A3E-9839-49F1-858E-F6056974B77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53A5F5F-2836-4B71-B34C-7FA029C7487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ADBADE-6C06-45C2-9438-89C309DA2F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31594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38BA2922-884E-4A40-970E-608E74A185B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55307" y="1914585"/>
            <a:ext cx="8714670" cy="2038289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A3DC9FB3-C932-4C59-8975-D42A6AA103F4}"/>
              </a:ext>
            </a:extLst>
          </p:cNvPr>
          <p:cNvSpPr txBox="1"/>
          <p:nvPr/>
        </p:nvSpPr>
        <p:spPr>
          <a:xfrm>
            <a:off x="755307" y="4183855"/>
            <a:ext cx="445897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1 Figure.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pBlast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lignment between the N- and C-termini PLP subunits of human GLDC. Alignment reveals a region of similarity with 26% identity and 48% similarity.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F7EE6FA9-8986-4319-A915-376782FFCD71}"/>
              </a:ext>
            </a:extLst>
          </p:cNvPr>
          <p:cNvSpPr txBox="1"/>
          <p:nvPr/>
        </p:nvSpPr>
        <p:spPr>
          <a:xfrm>
            <a:off x="674625" y="1576031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35533547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2</Words>
  <Application>Microsoft Office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e Farris</dc:creator>
  <cp:lastModifiedBy>Joe Farris</cp:lastModifiedBy>
  <cp:revision>1</cp:revision>
  <dcterms:created xsi:type="dcterms:W3CDTF">2019-12-16T19:57:07Z</dcterms:created>
  <dcterms:modified xsi:type="dcterms:W3CDTF">2019-12-16T19:57:25Z</dcterms:modified>
</cp:coreProperties>
</file>